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  <p:sldId id="274" r:id="rId3"/>
    <p:sldId id="260" r:id="rId4"/>
    <p:sldId id="270" r:id="rId5"/>
    <p:sldId id="273" r:id="rId6"/>
    <p:sldId id="261" r:id="rId7"/>
    <p:sldId id="26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CC33"/>
    <a:srgbClr val="27D3E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04" autoAdjust="0"/>
    <p:restoredTop sz="94660"/>
  </p:normalViewPr>
  <p:slideViewPr>
    <p:cSldViewPr snapToGrid="0">
      <p:cViewPr>
        <p:scale>
          <a:sx n="95" d="100"/>
          <a:sy n="95" d="100"/>
        </p:scale>
        <p:origin x="1134" y="5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98529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51358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461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50451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5677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8566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46990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024732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0345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68667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36749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CAAA2C-5FAA-4C3B-96EB-E69B58D8257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12/2022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C009C-1732-4373-A502-04786DF4664F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28367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2.png"/><Relationship Id="rId7" Type="http://schemas.openxmlformats.org/officeDocument/2006/relationships/image" Target="../media/image14.png"/><Relationship Id="rId12" Type="http://schemas.microsoft.com/office/2007/relationships/hdphoto" Target="../media/hdphoto5.wdp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16.png"/><Relationship Id="rId5" Type="http://schemas.openxmlformats.org/officeDocument/2006/relationships/image" Target="../media/image13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C89295A-A88E-D779-D5E7-77D0175F75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5832" y="473547"/>
            <a:ext cx="7739175" cy="4192721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63E47AD4-7722-EBC9-6A2C-69CFC2D00241}"/>
              </a:ext>
            </a:extLst>
          </p:cNvPr>
          <p:cNvSpPr txBox="1"/>
          <p:nvPr/>
        </p:nvSpPr>
        <p:spPr>
          <a:xfrm>
            <a:off x="861026" y="5734566"/>
            <a:ext cx="10965210" cy="92333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GB" b="1" dirty="0"/>
              <a:t>Fig. S1</a:t>
            </a:r>
            <a:r>
              <a:rPr lang="en-GB" dirty="0"/>
              <a:t>: Protein sequences of putative </a:t>
            </a:r>
            <a:r>
              <a:rPr lang="en-GB" dirty="0" err="1"/>
              <a:t>ferulate</a:t>
            </a:r>
            <a:r>
              <a:rPr lang="en-GB" dirty="0"/>
              <a:t> 5-hydroxylase (F5H) genes identified in barley. </a:t>
            </a:r>
            <a:r>
              <a:rPr lang="en-GB" b="1" dirty="0"/>
              <a:t>(S1.1) </a:t>
            </a:r>
            <a:r>
              <a:rPr lang="en-GB" dirty="0"/>
              <a:t>Amino acid sequence alignment of the barley F5Hs with Arabidopsis F5H (At4g36220); </a:t>
            </a:r>
            <a:r>
              <a:rPr lang="en-GB" b="1" dirty="0"/>
              <a:t>(S1.2) </a:t>
            </a:r>
            <a:r>
              <a:rPr lang="en-GB" dirty="0"/>
              <a:t>Five protein motifs that distinguish F5H enzymes.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C86AECA-0F37-DD03-DCB7-6858C2296689}"/>
              </a:ext>
            </a:extLst>
          </p:cNvPr>
          <p:cNvSpPr txBox="1"/>
          <p:nvPr/>
        </p:nvSpPr>
        <p:spPr>
          <a:xfrm>
            <a:off x="9394260" y="504234"/>
            <a:ext cx="95637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400" b="1" dirty="0"/>
              <a:t>(S1.1) </a:t>
            </a:r>
            <a:endParaRPr lang="en-GB" sz="24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2B91F11-D55B-5571-D445-E707512CC964}"/>
              </a:ext>
            </a:extLst>
          </p:cNvPr>
          <p:cNvSpPr txBox="1"/>
          <p:nvPr/>
        </p:nvSpPr>
        <p:spPr>
          <a:xfrm>
            <a:off x="9379798" y="4238836"/>
            <a:ext cx="95637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400" b="1" dirty="0"/>
              <a:t>(S1.2) </a:t>
            </a:r>
            <a:endParaRPr lang="en-GB" sz="2400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503F996-3F94-950D-59F3-DAC6C429A137}"/>
              </a:ext>
            </a:extLst>
          </p:cNvPr>
          <p:cNvGrpSpPr/>
          <p:nvPr/>
        </p:nvGrpSpPr>
        <p:grpSpPr>
          <a:xfrm>
            <a:off x="1746195" y="4856235"/>
            <a:ext cx="8892868" cy="737368"/>
            <a:chOff x="1721028" y="4814290"/>
            <a:chExt cx="8892868" cy="737368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30AC209-9535-4CDD-BD2E-462AA86F4524}"/>
                </a:ext>
              </a:extLst>
            </p:cNvPr>
            <p:cNvSpPr txBox="1"/>
            <p:nvPr/>
          </p:nvSpPr>
          <p:spPr>
            <a:xfrm>
              <a:off x="3154961" y="5217310"/>
              <a:ext cx="394642" cy="334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/>
                <a:t>A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E12DFE3-3107-44B5-8084-92B60A87113B}"/>
                </a:ext>
              </a:extLst>
            </p:cNvPr>
            <p:cNvSpPr txBox="1"/>
            <p:nvPr/>
          </p:nvSpPr>
          <p:spPr>
            <a:xfrm>
              <a:off x="7430940" y="5216311"/>
              <a:ext cx="394642" cy="334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/>
                <a:t>D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402353B-C286-462A-8ABF-10531C804B5E}"/>
                </a:ext>
              </a:extLst>
            </p:cNvPr>
            <p:cNvSpPr txBox="1"/>
            <p:nvPr/>
          </p:nvSpPr>
          <p:spPr>
            <a:xfrm>
              <a:off x="6632927" y="5216311"/>
              <a:ext cx="394642" cy="334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/>
                <a:t>C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60BC2CD-DD03-4601-BF66-CE9C8E83A371}"/>
                </a:ext>
              </a:extLst>
            </p:cNvPr>
            <p:cNvSpPr txBox="1"/>
            <p:nvPr/>
          </p:nvSpPr>
          <p:spPr>
            <a:xfrm>
              <a:off x="5646985" y="5216311"/>
              <a:ext cx="394642" cy="334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/>
                <a:t>B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96D0B41-3CF6-3628-DEC6-696B800A054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21028" y="4814290"/>
              <a:ext cx="8892868" cy="436254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B848097-2548-23D8-15D7-22302B9DF754}"/>
                </a:ext>
              </a:extLst>
            </p:cNvPr>
            <p:cNvSpPr txBox="1"/>
            <p:nvPr/>
          </p:nvSpPr>
          <p:spPr>
            <a:xfrm>
              <a:off x="8576096" y="5217310"/>
              <a:ext cx="3946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/>
                <a:t>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78517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C2C4339-E13E-467E-AED1-1479D82F2D3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796" r="13457" b="13040"/>
          <a:stretch/>
        </p:blipFill>
        <p:spPr>
          <a:xfrm>
            <a:off x="2120725" y="3991306"/>
            <a:ext cx="4169615" cy="180002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038685D-8142-426C-AAD3-B590DE3A8B7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796" r="13457" b="13013"/>
          <a:stretch/>
        </p:blipFill>
        <p:spPr>
          <a:xfrm>
            <a:off x="6515439" y="3991305"/>
            <a:ext cx="4168310" cy="1800021"/>
          </a:xfrm>
          <a:prstGeom prst="rect">
            <a:avLst/>
          </a:prstGeom>
        </p:spPr>
      </p:pic>
      <p:sp>
        <p:nvSpPr>
          <p:cNvPr id="16" name="Title 1">
            <a:extLst>
              <a:ext uri="{FF2B5EF4-FFF2-40B4-BE49-F238E27FC236}">
                <a16:creationId xmlns:a16="http://schemas.microsoft.com/office/drawing/2014/main" id="{3B083B99-F30B-41CC-8BC6-05ED8ECFBD9F}"/>
              </a:ext>
            </a:extLst>
          </p:cNvPr>
          <p:cNvSpPr txBox="1">
            <a:spLocks/>
          </p:cNvSpPr>
          <p:nvPr/>
        </p:nvSpPr>
        <p:spPr>
          <a:xfrm>
            <a:off x="751389" y="5980186"/>
            <a:ext cx="9597731" cy="8186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1800" b="1" dirty="0"/>
              <a:t>Fig.S2</a:t>
            </a:r>
            <a:r>
              <a:rPr lang="en-GB" sz="1800" dirty="0"/>
              <a:t>: Expression of putative</a:t>
            </a:r>
            <a:r>
              <a:rPr lang="en-GB" sz="1800" i="1" dirty="0"/>
              <a:t> HvF5H </a:t>
            </a:r>
            <a:r>
              <a:rPr lang="en-GB" sz="1800" dirty="0"/>
              <a:t>genes</a:t>
            </a:r>
            <a:r>
              <a:rPr lang="en-GB" sz="1800" i="1" dirty="0"/>
              <a:t> </a:t>
            </a:r>
            <a:r>
              <a:rPr lang="en-GB" sz="1800" dirty="0"/>
              <a:t>in 16 different tissues. Expression data extracted from Barley Expression Database “https://ics.hutton.ac.uk/eorna/index.html”</a:t>
            </a:r>
          </a:p>
          <a:p>
            <a:pPr algn="l"/>
            <a:endParaRPr lang="en-GB" sz="1800" i="1" dirty="0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0C2EEA0F-96AC-44CE-849C-970A779C6024}"/>
              </a:ext>
            </a:extLst>
          </p:cNvPr>
          <p:cNvGrpSpPr/>
          <p:nvPr/>
        </p:nvGrpSpPr>
        <p:grpSpPr>
          <a:xfrm>
            <a:off x="1422674" y="334621"/>
            <a:ext cx="9628721" cy="3547253"/>
            <a:chOff x="1244163" y="998493"/>
            <a:chExt cx="9628721" cy="3547253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577426CC-9F8D-49D9-AA44-8924B78B53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808" t="7919" r="1563" b="11136"/>
            <a:stretch/>
          </p:blipFill>
          <p:spPr>
            <a:xfrm>
              <a:off x="1600095" y="998493"/>
              <a:ext cx="9272789" cy="3297476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01D5054-E205-438A-AE07-906A8892271A}"/>
                </a:ext>
              </a:extLst>
            </p:cNvPr>
            <p:cNvSpPr txBox="1"/>
            <p:nvPr/>
          </p:nvSpPr>
          <p:spPr>
            <a:xfrm rot="10800000">
              <a:off x="1244163" y="1573975"/>
              <a:ext cx="430887" cy="2197408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pPr algn="ctr"/>
              <a:r>
                <a:rPr lang="en-GB" sz="1600" b="1" dirty="0"/>
                <a:t>Transcript level (TPM)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74D0757-7FF8-4527-8E4C-F2524E403AAD}"/>
                </a:ext>
              </a:extLst>
            </p:cNvPr>
            <p:cNvSpPr txBox="1"/>
            <p:nvPr/>
          </p:nvSpPr>
          <p:spPr>
            <a:xfrm rot="16200000">
              <a:off x="5541858" y="3216210"/>
              <a:ext cx="461665" cy="2197408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pPr algn="ctr"/>
              <a:r>
                <a:rPr lang="en-GB" b="1" dirty="0"/>
                <a:t>Tissues</a:t>
              </a: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B29477DB-B0B6-4B01-B87B-470D33E343A1}"/>
                </a:ext>
              </a:extLst>
            </p:cNvPr>
            <p:cNvCxnSpPr>
              <a:cxnSpLocks/>
            </p:cNvCxnSpPr>
            <p:nvPr/>
          </p:nvCxnSpPr>
          <p:spPr>
            <a:xfrm>
              <a:off x="2010201" y="1816639"/>
              <a:ext cx="23304" cy="180826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3209AC99-58DC-4883-8360-2A4862F41F9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023104" y="3624905"/>
              <a:ext cx="7612550" cy="4231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700935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F606F45-1C8B-A4B4-9E6A-4B6C9E53ADC8}"/>
              </a:ext>
            </a:extLst>
          </p:cNvPr>
          <p:cNvGrpSpPr/>
          <p:nvPr/>
        </p:nvGrpSpPr>
        <p:grpSpPr>
          <a:xfrm>
            <a:off x="800071" y="4151565"/>
            <a:ext cx="3768395" cy="795864"/>
            <a:chOff x="800071" y="4151565"/>
            <a:chExt cx="3768395" cy="795864"/>
          </a:xfrm>
        </p:grpSpPr>
        <p:sp>
          <p:nvSpPr>
            <p:cNvPr id="7" name="Right Arrow 6"/>
            <p:cNvSpPr/>
            <p:nvPr/>
          </p:nvSpPr>
          <p:spPr>
            <a:xfrm>
              <a:off x="2111971" y="4409213"/>
              <a:ext cx="570440" cy="288032"/>
            </a:xfrm>
            <a:prstGeom prst="rightArrow">
              <a:avLst/>
            </a:prstGeom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Right Arrow 7"/>
            <p:cNvSpPr/>
            <p:nvPr/>
          </p:nvSpPr>
          <p:spPr>
            <a:xfrm rot="10800000">
              <a:off x="3141152" y="4405481"/>
              <a:ext cx="612975" cy="288032"/>
            </a:xfrm>
            <a:prstGeom prst="rightArrow">
              <a:avLst/>
            </a:prstGeom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Rectangle 8"/>
            <p:cNvSpPr/>
            <p:nvPr/>
          </p:nvSpPr>
          <p:spPr>
            <a:xfrm>
              <a:off x="2704637" y="4405481"/>
              <a:ext cx="409822" cy="28803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Right Arrow 9"/>
            <p:cNvSpPr/>
            <p:nvPr/>
          </p:nvSpPr>
          <p:spPr>
            <a:xfrm>
              <a:off x="800071" y="4394885"/>
              <a:ext cx="1255940" cy="288032"/>
            </a:xfrm>
            <a:prstGeom prst="rightArrow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802057" y="4385360"/>
              <a:ext cx="631470" cy="288032"/>
            </a:xfrm>
            <a:prstGeom prst="rect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91022" y="4673392"/>
              <a:ext cx="93610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 err="1"/>
                <a:t>Ubi</a:t>
              </a:r>
              <a:r>
                <a:rPr lang="en-GB" sz="1050" dirty="0"/>
                <a:t> promoter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146116" y="4693513"/>
              <a:ext cx="65594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i="1" dirty="0"/>
                <a:t>HvF5H1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069220" y="4673392"/>
              <a:ext cx="65594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i="1" dirty="0"/>
                <a:t>HvF5H1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722097" y="4151565"/>
              <a:ext cx="84636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Terminator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606063" y="4185681"/>
              <a:ext cx="67679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/>
                <a:t> introns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8417797" y="1610489"/>
            <a:ext cx="2613572" cy="1240977"/>
            <a:chOff x="8597353" y="3879465"/>
            <a:chExt cx="2613572" cy="1240977"/>
          </a:xfrm>
        </p:grpSpPr>
        <p:grpSp>
          <p:nvGrpSpPr>
            <p:cNvPr id="31" name="Group 30"/>
            <p:cNvGrpSpPr/>
            <p:nvPr/>
          </p:nvGrpSpPr>
          <p:grpSpPr>
            <a:xfrm>
              <a:off x="8597353" y="3879465"/>
              <a:ext cx="2613571" cy="369332"/>
              <a:chOff x="8597353" y="3879465"/>
              <a:chExt cx="2613571" cy="369332"/>
            </a:xfrm>
          </p:grpSpPr>
          <p:sp>
            <p:nvSpPr>
              <p:cNvPr id="25" name="Rectangle 24"/>
              <p:cNvSpPr/>
              <p:nvPr/>
            </p:nvSpPr>
            <p:spPr>
              <a:xfrm>
                <a:off x="8597353" y="3985085"/>
                <a:ext cx="695325" cy="200025"/>
              </a:xfrm>
              <a:prstGeom prst="rect">
                <a:avLst/>
              </a:prstGeom>
              <a:solidFill>
                <a:srgbClr val="33CC3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9292677" y="3879465"/>
                <a:ext cx="191824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Transmembrane</a:t>
                </a:r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8597353" y="4751110"/>
              <a:ext cx="2613572" cy="369332"/>
              <a:chOff x="8597353" y="4751110"/>
              <a:chExt cx="2613572" cy="369332"/>
            </a:xfrm>
          </p:grpSpPr>
          <p:sp>
            <p:nvSpPr>
              <p:cNvPr id="27" name="Rectangle 26"/>
              <p:cNvSpPr/>
              <p:nvPr/>
            </p:nvSpPr>
            <p:spPr>
              <a:xfrm>
                <a:off x="8597353" y="4851123"/>
                <a:ext cx="695325" cy="200025"/>
              </a:xfrm>
              <a:prstGeom prst="rect">
                <a:avLst/>
              </a:prstGeom>
              <a:solidFill>
                <a:srgbClr val="27D3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9292678" y="4751110"/>
                <a:ext cx="191824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P450</a:t>
                </a:r>
              </a:p>
            </p:txBody>
          </p:sp>
        </p:grpSp>
        <p:grpSp>
          <p:nvGrpSpPr>
            <p:cNvPr id="32" name="Group 31"/>
            <p:cNvGrpSpPr/>
            <p:nvPr/>
          </p:nvGrpSpPr>
          <p:grpSpPr>
            <a:xfrm>
              <a:off x="8597353" y="4321089"/>
              <a:ext cx="2613572" cy="369332"/>
              <a:chOff x="8597353" y="4321089"/>
              <a:chExt cx="2613572" cy="369332"/>
            </a:xfrm>
          </p:grpSpPr>
          <p:sp>
            <p:nvSpPr>
              <p:cNvPr id="26" name="Rectangle 25"/>
              <p:cNvSpPr/>
              <p:nvPr/>
            </p:nvSpPr>
            <p:spPr>
              <a:xfrm>
                <a:off x="8597353" y="4418104"/>
                <a:ext cx="695325" cy="20002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9292678" y="4321089"/>
                <a:ext cx="191824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RNAi sequence</a:t>
                </a:r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CAEED372-6A60-4BBF-9862-0758E3EFD2F7}"/>
              </a:ext>
            </a:extLst>
          </p:cNvPr>
          <p:cNvGrpSpPr/>
          <p:nvPr/>
        </p:nvGrpSpPr>
        <p:grpSpPr>
          <a:xfrm>
            <a:off x="517729" y="1225145"/>
            <a:ext cx="7552405" cy="2066732"/>
            <a:chOff x="1364035" y="1322421"/>
            <a:chExt cx="7552405" cy="2066732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51523" y="1447392"/>
              <a:ext cx="7464917" cy="1941761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17D78E7-9292-409D-A0D5-8224FC29A8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4024" b="26121"/>
            <a:stretch/>
          </p:blipFill>
          <p:spPr>
            <a:xfrm>
              <a:off x="1364035" y="1322421"/>
              <a:ext cx="1889924" cy="349214"/>
            </a:xfrm>
            <a:prstGeom prst="rect">
              <a:avLst/>
            </a:prstGeom>
          </p:spPr>
        </p:pic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9D7BCA1D-ECAE-4991-91CE-06807A29B5A2}"/>
              </a:ext>
            </a:extLst>
          </p:cNvPr>
          <p:cNvSpPr txBox="1"/>
          <p:nvPr/>
        </p:nvSpPr>
        <p:spPr>
          <a:xfrm>
            <a:off x="517730" y="5309689"/>
            <a:ext cx="11246922" cy="1477328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GB" b="1" dirty="0"/>
              <a:t>Fig. S3</a:t>
            </a:r>
            <a:r>
              <a:rPr lang="en-GB" dirty="0"/>
              <a:t>: Overview of the HvF5H1 sequence selection for the RNAi transformation construct. </a:t>
            </a:r>
            <a:r>
              <a:rPr lang="en-GB" b="1" dirty="0"/>
              <a:t>(A)</a:t>
            </a:r>
            <a:r>
              <a:rPr lang="en-GB" dirty="0"/>
              <a:t> A 669 bp fragment of HvF5H1 from Golden Promise cDNA (shown in yellow) was used in sense and antisense orientation in a hairpin construct; </a:t>
            </a:r>
            <a:r>
              <a:rPr lang="en-GB" b="1" dirty="0"/>
              <a:t>(B) </a:t>
            </a:r>
            <a:r>
              <a:rPr lang="en-GB" dirty="0"/>
              <a:t>The construct was made using pBract207 with the maize ZmUbi1 promoter (GenBank:EU161568) and </a:t>
            </a:r>
            <a:r>
              <a:rPr lang="en-GB" dirty="0" err="1"/>
              <a:t>CaMv</a:t>
            </a:r>
            <a:r>
              <a:rPr lang="en-GB" dirty="0"/>
              <a:t> 35S 5’ terminator. The intron separating both arms of the hairpin was taken from wheat RGA2. See material and methods for details.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8981275-62E6-B018-0782-895FAA0FBDF5}"/>
              </a:ext>
            </a:extLst>
          </p:cNvPr>
          <p:cNvSpPr txBox="1"/>
          <p:nvPr/>
        </p:nvSpPr>
        <p:spPr>
          <a:xfrm>
            <a:off x="517729" y="763480"/>
            <a:ext cx="70775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400" b="1" dirty="0"/>
              <a:t>(A) </a:t>
            </a:r>
            <a:endParaRPr lang="en-GB" sz="24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AECF645-2240-B821-CDCA-367FB2C5F91C}"/>
              </a:ext>
            </a:extLst>
          </p:cNvPr>
          <p:cNvSpPr txBox="1"/>
          <p:nvPr/>
        </p:nvSpPr>
        <p:spPr>
          <a:xfrm>
            <a:off x="608891" y="3657015"/>
            <a:ext cx="70775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400" b="1" dirty="0"/>
              <a:t>(B) </a:t>
            </a:r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9434483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263F2175-1CEF-ADD7-2E93-74A465340631}"/>
              </a:ext>
            </a:extLst>
          </p:cNvPr>
          <p:cNvGrpSpPr/>
          <p:nvPr/>
        </p:nvGrpSpPr>
        <p:grpSpPr>
          <a:xfrm>
            <a:off x="1127440" y="562200"/>
            <a:ext cx="4175399" cy="3470954"/>
            <a:chOff x="868032" y="549866"/>
            <a:chExt cx="4175399" cy="3470954"/>
          </a:xfrm>
        </p:grpSpPr>
        <p:pic>
          <p:nvPicPr>
            <p:cNvPr id="2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8032" y="1113171"/>
              <a:ext cx="4175399" cy="290764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4494542" y="549866"/>
              <a:ext cx="3883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b="1" dirty="0"/>
                <a:t>A</a:t>
              </a: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0CF6C432-53CF-4ACC-B4DD-E1DD95EBC430}"/>
              </a:ext>
            </a:extLst>
          </p:cNvPr>
          <p:cNvSpPr txBox="1"/>
          <p:nvPr/>
        </p:nvSpPr>
        <p:spPr>
          <a:xfrm>
            <a:off x="314785" y="5467551"/>
            <a:ext cx="113248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.S4</a:t>
            </a:r>
            <a:r>
              <a:rPr lang="en-GB" b="1" dirty="0">
                <a:cs typeface="Times New Roman" panose="02020603050405020304" pitchFamily="18" charset="0"/>
              </a:rPr>
              <a:t>: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8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HvF5H1</a:t>
            </a:r>
            <a:r>
              <a:rPr lang="en-GB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RNAi transformation and selection of independent lines. </a:t>
            </a:r>
            <a:r>
              <a:rPr lang="en-GB" sz="18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GB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0 generation consisted of independent </a:t>
            </a:r>
            <a:r>
              <a:rPr lang="en-GB" sz="18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HvF5H1</a:t>
            </a:r>
            <a:r>
              <a:rPr lang="en-GB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RNAi plants following embryo transformation; </a:t>
            </a:r>
            <a:r>
              <a:rPr lang="en-GB" sz="18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GB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creening for </a:t>
            </a:r>
            <a:r>
              <a:rPr lang="en-GB" sz="18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HvF5H1</a:t>
            </a:r>
            <a:r>
              <a:rPr lang="en-GB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expression and number of RNAi construct insertion sites in 23 T0 plants. *: Transgenic lines that were advanced to the T1 generation. The error bars represent standard errors between at least 3 replicates (different tissue samples from the one plant). </a:t>
            </a:r>
            <a:endParaRPr lang="en-GB" dirty="0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C4D61D05-B4E4-DA83-6FF5-52E8A56431E9}"/>
              </a:ext>
            </a:extLst>
          </p:cNvPr>
          <p:cNvGrpSpPr/>
          <p:nvPr/>
        </p:nvGrpSpPr>
        <p:grpSpPr>
          <a:xfrm>
            <a:off x="5958160" y="603615"/>
            <a:ext cx="5620018" cy="4690304"/>
            <a:chOff x="5958160" y="603615"/>
            <a:chExt cx="5620018" cy="4690304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78DC12A-1EDB-7D43-514C-CA4833A3264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58160" y="603615"/>
              <a:ext cx="5620018" cy="3586667"/>
            </a:xfrm>
            <a:prstGeom prst="rect">
              <a:avLst/>
            </a:prstGeom>
          </p:spPr>
        </p:pic>
        <p:sp>
          <p:nvSpPr>
            <p:cNvPr id="32" name="Rectangle 31"/>
            <p:cNvSpPr/>
            <p:nvPr/>
          </p:nvSpPr>
          <p:spPr>
            <a:xfrm>
              <a:off x="7044554" y="4047424"/>
              <a:ext cx="4191631" cy="124649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b="1" dirty="0">
                  <a:solidFill>
                    <a:srgbClr val="92D050"/>
                  </a:solidFill>
                </a:rPr>
                <a:t>GREEN:  Single insertion site of RNAi cassette</a:t>
              </a:r>
            </a:p>
            <a:p>
              <a:r>
                <a:rPr lang="en-GB" sz="1400" b="1" dirty="0">
                  <a:solidFill>
                    <a:srgbClr val="FF0000"/>
                  </a:solidFill>
                </a:rPr>
                <a:t>RED :  More than one insertion site of RNAi cassette</a:t>
              </a:r>
            </a:p>
            <a:p>
              <a:pPr>
                <a:spcAft>
                  <a:spcPts val="600"/>
                </a:spcAft>
              </a:pPr>
              <a:r>
                <a:rPr lang="en-GB" sz="1400" b="1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BLUE: No information</a:t>
              </a:r>
            </a:p>
            <a:p>
              <a:r>
                <a:rPr lang="en-GB" sz="1400" b="1" dirty="0"/>
                <a:t>* T0 plants developed to T1 generation</a:t>
              </a:r>
            </a:p>
            <a:p>
              <a:r>
                <a:rPr lang="en-GB" sz="1400" dirty="0"/>
                <a:t>EV: Empty vector               WT: Wild type</a:t>
              </a: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2A61EBC5-78F4-28D0-98BA-9514FA07F58C}"/>
                </a:ext>
              </a:extLst>
            </p:cNvPr>
            <p:cNvGrpSpPr/>
            <p:nvPr/>
          </p:nvGrpSpPr>
          <p:grpSpPr>
            <a:xfrm>
              <a:off x="10260269" y="3106141"/>
              <a:ext cx="940334" cy="373999"/>
              <a:chOff x="10176247" y="3201391"/>
              <a:chExt cx="940334" cy="373999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B02EBC20-A923-4068-8F21-3D15A6BC6DB7}"/>
                  </a:ext>
                </a:extLst>
              </p:cNvPr>
              <p:cNvSpPr txBox="1"/>
              <p:nvPr/>
            </p:nvSpPr>
            <p:spPr>
              <a:xfrm>
                <a:off x="10759432" y="3201391"/>
                <a:ext cx="35714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*</a:t>
                </a:r>
                <a:endParaRPr lang="en-GB" sz="1400" dirty="0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14168CA1-9D95-42D8-8F49-0A995A0FD02F}"/>
                  </a:ext>
                </a:extLst>
              </p:cNvPr>
              <p:cNvSpPr txBox="1"/>
              <p:nvPr/>
            </p:nvSpPr>
            <p:spPr>
              <a:xfrm>
                <a:off x="10580440" y="3206058"/>
                <a:ext cx="35714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*</a:t>
                </a:r>
                <a:endParaRPr lang="en-GB" sz="1400" dirty="0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26DF3132-2158-428D-8D11-569B2FAB570E}"/>
                  </a:ext>
                </a:extLst>
              </p:cNvPr>
              <p:cNvSpPr txBox="1"/>
              <p:nvPr/>
            </p:nvSpPr>
            <p:spPr>
              <a:xfrm>
                <a:off x="10176247" y="3201391"/>
                <a:ext cx="35714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*</a:t>
                </a:r>
                <a:endParaRPr lang="en-GB" sz="1400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4EC89383-B03C-405B-9B2A-08F94AE87244}"/>
                  </a:ext>
                </a:extLst>
              </p:cNvPr>
              <p:cNvSpPr txBox="1"/>
              <p:nvPr/>
            </p:nvSpPr>
            <p:spPr>
              <a:xfrm>
                <a:off x="10354821" y="3201391"/>
                <a:ext cx="35714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*</a:t>
                </a:r>
                <a:endParaRPr lang="en-GB" sz="1400" dirty="0"/>
              </a:p>
            </p:txBody>
          </p: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9BA8D391-27B5-4E21-8B09-098A5CC72713}"/>
                </a:ext>
              </a:extLst>
            </p:cNvPr>
            <p:cNvSpPr txBox="1"/>
            <p:nvPr/>
          </p:nvSpPr>
          <p:spPr>
            <a:xfrm>
              <a:off x="8925415" y="3101837"/>
              <a:ext cx="357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*</a:t>
              </a:r>
              <a:endParaRPr lang="en-GB" sz="14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BD53FE3-CDC1-480C-B9B6-F34A55D60F5C}"/>
                </a:ext>
              </a:extLst>
            </p:cNvPr>
            <p:cNvSpPr txBox="1"/>
            <p:nvPr/>
          </p:nvSpPr>
          <p:spPr>
            <a:xfrm>
              <a:off x="8364456" y="2919855"/>
              <a:ext cx="357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*</a:t>
              </a:r>
              <a:endParaRPr lang="en-GB" sz="140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C4931A5-79E1-4CA4-B35A-C06F8A18E276}"/>
                </a:ext>
              </a:extLst>
            </p:cNvPr>
            <p:cNvSpPr txBox="1"/>
            <p:nvPr/>
          </p:nvSpPr>
          <p:spPr>
            <a:xfrm>
              <a:off x="7977356" y="2702110"/>
              <a:ext cx="357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*</a:t>
              </a:r>
              <a:endParaRPr lang="en-GB" sz="14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0666650" y="708390"/>
              <a:ext cx="3883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b="1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338043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1353581" y="4898314"/>
            <a:ext cx="10109890" cy="138562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1800" b="1" dirty="0"/>
              <a:t>Fig.S5</a:t>
            </a:r>
            <a:r>
              <a:rPr lang="en-GB" sz="1800" dirty="0"/>
              <a:t>:</a:t>
            </a:r>
            <a:r>
              <a:rPr lang="en-GB" sz="1800" dirty="0">
                <a:effectLst/>
                <a:latin typeface="+mn-lt"/>
                <a:ea typeface="Calibri" panose="020F0502020204030204" pitchFamily="34" charset="0"/>
              </a:rPr>
              <a:t>Expression of </a:t>
            </a:r>
            <a:r>
              <a:rPr lang="en-GB" sz="1800" i="1" dirty="0">
                <a:effectLst/>
                <a:latin typeface="+mn-lt"/>
                <a:ea typeface="Calibri" panose="020F0502020204030204" pitchFamily="34" charset="0"/>
              </a:rPr>
              <a:t>HvF5H1</a:t>
            </a:r>
            <a:r>
              <a:rPr lang="en-GB" sz="1800" dirty="0">
                <a:effectLst/>
                <a:latin typeface="+mn-lt"/>
                <a:ea typeface="Calibri" panose="020F0502020204030204" pitchFamily="34" charset="0"/>
              </a:rPr>
              <a:t> in </a:t>
            </a:r>
            <a:r>
              <a:rPr lang="en-GB" sz="1800" i="1" dirty="0">
                <a:effectLst/>
                <a:latin typeface="+mn-lt"/>
                <a:ea typeface="Calibri" panose="020F0502020204030204" pitchFamily="34" charset="0"/>
              </a:rPr>
              <a:t>HvF5H1</a:t>
            </a:r>
            <a:r>
              <a:rPr lang="en-GB" sz="1800" dirty="0">
                <a:effectLst/>
                <a:latin typeface="+mn-lt"/>
                <a:ea typeface="Calibri" panose="020F0502020204030204" pitchFamily="34" charset="0"/>
              </a:rPr>
              <a:t>-RNAi homozygote and </a:t>
            </a:r>
            <a:r>
              <a:rPr lang="en-GB" sz="1800" dirty="0" err="1">
                <a:effectLst/>
                <a:latin typeface="+mn-lt"/>
                <a:ea typeface="Calibri" panose="020F0502020204030204" pitchFamily="34" charset="0"/>
              </a:rPr>
              <a:t>azygote</a:t>
            </a:r>
            <a:r>
              <a:rPr lang="en-GB" sz="1800" dirty="0">
                <a:effectLst/>
                <a:latin typeface="+mn-lt"/>
                <a:ea typeface="Calibri" panose="020F0502020204030204" pitchFamily="34" charset="0"/>
              </a:rPr>
              <a:t> plants of selected transgenic lines. Data is presented as relative abundance compared to expression of HvF5H1 in empty vector (EV) plants. As </a:t>
            </a:r>
            <a:r>
              <a:rPr lang="en-GB" sz="1800" dirty="0" err="1">
                <a:effectLst/>
                <a:latin typeface="+mn-lt"/>
                <a:ea typeface="Calibri" panose="020F0502020204030204" pitchFamily="34" charset="0"/>
              </a:rPr>
              <a:t>azygote</a:t>
            </a:r>
            <a:r>
              <a:rPr lang="en-GB" sz="1800" dirty="0">
                <a:effectLst/>
                <a:latin typeface="+mn-lt"/>
                <a:ea typeface="Calibri" panose="020F0502020204030204" pitchFamily="34" charset="0"/>
              </a:rPr>
              <a:t> plants were not available for line T, the EV control was used as a replacement. The error bars represent standard errors between biological triplicates (i.e. independent plants). </a:t>
            </a:r>
            <a:endParaRPr lang="en-GB" sz="1600" i="1" dirty="0">
              <a:latin typeface="+mn-lt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087F5BF-F652-FE6A-21A4-3532F4D642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5250" y="837388"/>
            <a:ext cx="4828450" cy="3389670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69989317-141E-D891-9C6C-44C0A8C6B887}"/>
              </a:ext>
            </a:extLst>
          </p:cNvPr>
          <p:cNvGrpSpPr/>
          <p:nvPr/>
        </p:nvGrpSpPr>
        <p:grpSpPr>
          <a:xfrm>
            <a:off x="3922653" y="4376319"/>
            <a:ext cx="4155089" cy="276999"/>
            <a:chOff x="2486036" y="4154024"/>
            <a:chExt cx="4155089" cy="276999"/>
          </a:xfrm>
        </p:grpSpPr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841D711A-B0CD-26D9-07F3-35047065CBDD}"/>
                </a:ext>
              </a:extLst>
            </p:cNvPr>
            <p:cNvSpPr/>
            <p:nvPr/>
          </p:nvSpPr>
          <p:spPr>
            <a:xfrm>
              <a:off x="2486036" y="4194958"/>
              <a:ext cx="233649" cy="182538"/>
            </a:xfrm>
            <a:prstGeom prst="rect">
              <a:avLst/>
            </a:prstGeom>
            <a:solidFill>
              <a:srgbClr val="4472C4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DB5FBF3-20FF-3025-7E1D-EDCA0FF92371}"/>
                </a:ext>
              </a:extLst>
            </p:cNvPr>
            <p:cNvSpPr txBox="1"/>
            <p:nvPr/>
          </p:nvSpPr>
          <p:spPr>
            <a:xfrm>
              <a:off x="2670142" y="4154024"/>
              <a:ext cx="1246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/>
                <a:t>RNAi</a:t>
              </a:r>
              <a:r>
                <a:rPr lang="en-GB" sz="1200" b="1" dirty="0"/>
                <a:t> plants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4E6176CB-A165-84B7-39CB-56CC8B1C0B03}"/>
                </a:ext>
              </a:extLst>
            </p:cNvPr>
            <p:cNvSpPr/>
            <p:nvPr/>
          </p:nvSpPr>
          <p:spPr>
            <a:xfrm>
              <a:off x="3715945" y="4200996"/>
              <a:ext cx="233649" cy="182538"/>
            </a:xfrm>
            <a:prstGeom prst="rect">
              <a:avLst/>
            </a:prstGeom>
            <a:solidFill>
              <a:schemeClr val="accent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4E5662E-86F8-AF97-BAE5-FC7B60C31F56}"/>
                </a:ext>
              </a:extLst>
            </p:cNvPr>
            <p:cNvSpPr txBox="1"/>
            <p:nvPr/>
          </p:nvSpPr>
          <p:spPr>
            <a:xfrm>
              <a:off x="3916270" y="4154024"/>
              <a:ext cx="1246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Azygote plants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664F6F1-FA92-CDC2-6F10-0B602FF36F49}"/>
                </a:ext>
              </a:extLst>
            </p:cNvPr>
            <p:cNvSpPr/>
            <p:nvPr/>
          </p:nvSpPr>
          <p:spPr>
            <a:xfrm>
              <a:off x="5205430" y="4200996"/>
              <a:ext cx="233649" cy="18253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8E66DB6-F2A5-1E2D-ADB4-99CA68C17496}"/>
                </a:ext>
              </a:extLst>
            </p:cNvPr>
            <p:cNvSpPr txBox="1"/>
            <p:nvPr/>
          </p:nvSpPr>
          <p:spPr>
            <a:xfrm>
              <a:off x="5394997" y="4154024"/>
              <a:ext cx="1246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Empty vecto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989865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305749" y="706297"/>
            <a:ext cx="1512168" cy="2224283"/>
            <a:chOff x="2901668" y="1467076"/>
            <a:chExt cx="1512168" cy="2224283"/>
          </a:xfrm>
        </p:grpSpPr>
        <p:pic>
          <p:nvPicPr>
            <p:cNvPr id="5123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2737639" y="2046334"/>
              <a:ext cx="1835650" cy="1454400"/>
            </a:xfrm>
            <a:prstGeom prst="rect">
              <a:avLst/>
            </a:prstGeom>
            <a:noFill/>
            <a:ln w="19050">
              <a:solidFill>
                <a:schemeClr val="tx2">
                  <a:lumMod val="75000"/>
                </a:schemeClr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8" name="TextBox 27"/>
            <p:cNvSpPr txBox="1"/>
            <p:nvPr/>
          </p:nvSpPr>
          <p:spPr>
            <a:xfrm>
              <a:off x="2901668" y="1467076"/>
              <a:ext cx="151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/>
                <a:t>B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7187946" y="763252"/>
            <a:ext cx="1592603" cy="2167328"/>
            <a:chOff x="4509573" y="1467965"/>
            <a:chExt cx="1592603" cy="2167328"/>
          </a:xfrm>
        </p:grpSpPr>
        <p:pic>
          <p:nvPicPr>
            <p:cNvPr id="19" name="Picture 17" descr="C:\Users\mh40706\Desktop\Images T2\Rep 8\T10\Maule\Untitled-89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13000" contras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4382336" y="1990268"/>
              <a:ext cx="1835650" cy="1454400"/>
            </a:xfrm>
            <a:prstGeom prst="rect">
              <a:avLst/>
            </a:prstGeom>
            <a:noFill/>
            <a:ln w="19685">
              <a:solidFill>
                <a:schemeClr val="tx2">
                  <a:lumMod val="75000"/>
                </a:schemeClr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9" name="TextBox 28"/>
            <p:cNvSpPr txBox="1"/>
            <p:nvPr/>
          </p:nvSpPr>
          <p:spPr>
            <a:xfrm>
              <a:off x="4509573" y="1467965"/>
              <a:ext cx="15926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/>
                <a:t>W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5299698" y="770984"/>
            <a:ext cx="1592603" cy="2159596"/>
            <a:chOff x="6149912" y="1474656"/>
            <a:chExt cx="1592603" cy="2159596"/>
          </a:xfrm>
        </p:grpSpPr>
        <p:pic>
          <p:nvPicPr>
            <p:cNvPr id="17" name="Picture 19" descr="C:\Users\mh40706\Desktop\Images T2\Rep 5\T10\Maule\Untitled-6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3000" contrast="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88" r="16671"/>
            <a:stretch/>
          </p:blipFill>
          <p:spPr bwMode="auto">
            <a:xfrm>
              <a:off x="6213783" y="1798252"/>
              <a:ext cx="1464863" cy="1836000"/>
            </a:xfrm>
            <a:prstGeom prst="rect">
              <a:avLst/>
            </a:prstGeom>
            <a:noFill/>
            <a:ln w="19050">
              <a:solidFill>
                <a:schemeClr val="tx2">
                  <a:lumMod val="75000"/>
                </a:schemeClr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" name="TextBox 29"/>
            <p:cNvSpPr txBox="1"/>
            <p:nvPr/>
          </p:nvSpPr>
          <p:spPr>
            <a:xfrm>
              <a:off x="6149912" y="1474656"/>
              <a:ext cx="15926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/>
                <a:t>T</a:t>
              </a:r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3217697" y="3175060"/>
            <a:ext cx="5756603" cy="1819125"/>
            <a:chOff x="3087555" y="4038257"/>
            <a:chExt cx="5756603" cy="1819125"/>
          </a:xfrm>
        </p:grpSpPr>
        <p:grpSp>
          <p:nvGrpSpPr>
            <p:cNvPr id="38" name="Group 37"/>
            <p:cNvGrpSpPr/>
            <p:nvPr/>
          </p:nvGrpSpPr>
          <p:grpSpPr>
            <a:xfrm>
              <a:off x="3087555" y="4038257"/>
              <a:ext cx="5756603" cy="1819125"/>
              <a:chOff x="1908594" y="3986500"/>
              <a:chExt cx="5756603" cy="1819125"/>
            </a:xfrm>
          </p:grpSpPr>
          <p:grpSp>
            <p:nvGrpSpPr>
              <p:cNvPr id="26" name="Group 25"/>
              <p:cNvGrpSpPr/>
              <p:nvPr/>
            </p:nvGrpSpPr>
            <p:grpSpPr>
              <a:xfrm>
                <a:off x="1908594" y="4005064"/>
                <a:ext cx="1836000" cy="1800561"/>
                <a:chOff x="1908594" y="4162959"/>
                <a:chExt cx="1836000" cy="1800561"/>
              </a:xfrm>
            </p:grpSpPr>
            <p:pic>
              <p:nvPicPr>
                <p:cNvPr id="32" name="Picture 4"/>
                <p:cNvPicPr preferRelativeResize="0">
                  <a:picLocks noChangeArrowheads="1"/>
                </p:cNvPicPr>
                <p:nvPr/>
              </p:nvPicPr>
              <p:blipFill>
                <a:blip r:embed="rId7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11000" contrast="11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908594" y="4509120"/>
                  <a:ext cx="1836000" cy="1454400"/>
                </a:xfrm>
                <a:prstGeom prst="rect">
                  <a:avLst/>
                </a:prstGeom>
                <a:noFill/>
                <a:ln w="19050">
                  <a:solidFill>
                    <a:schemeClr val="tx2">
                      <a:lumMod val="75000"/>
                    </a:schemeClr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3" name="TextBox 32"/>
                <p:cNvSpPr txBox="1"/>
                <p:nvPr/>
              </p:nvSpPr>
              <p:spPr>
                <a:xfrm>
                  <a:off x="2070510" y="4162959"/>
                  <a:ext cx="151216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dirty="0"/>
                    <a:t>Empty Vector</a:t>
                  </a:r>
                </a:p>
              </p:txBody>
            </p:sp>
          </p:grpSp>
          <p:grpSp>
            <p:nvGrpSpPr>
              <p:cNvPr id="27" name="Group 26"/>
              <p:cNvGrpSpPr/>
              <p:nvPr/>
            </p:nvGrpSpPr>
            <p:grpSpPr>
              <a:xfrm>
                <a:off x="3884857" y="4005064"/>
                <a:ext cx="1836000" cy="1796480"/>
                <a:chOff x="4032143" y="4147081"/>
                <a:chExt cx="1836000" cy="1796480"/>
              </a:xfrm>
            </p:grpSpPr>
            <p:pic>
              <p:nvPicPr>
                <p:cNvPr id="34" name="Picture 2" descr="C:\Users\mh40706\Desktop\Images T2\Rep 5\GPWT\Maule\Untitled-28.tif"/>
                <p:cNvPicPr preferRelativeResize="0">
                  <a:picLocks noChangeArrowheads="1"/>
                </p:cNvPicPr>
                <p:nvPr/>
              </p:nvPicPr>
              <p:blipFill>
                <a:blip r:embed="rId9" cstate="print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8000" contrast="1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032143" y="4489161"/>
                  <a:ext cx="1836000" cy="1454400"/>
                </a:xfrm>
                <a:prstGeom prst="rect">
                  <a:avLst/>
                </a:prstGeom>
                <a:noFill/>
                <a:ln w="19050">
                  <a:solidFill>
                    <a:schemeClr val="tx2">
                      <a:lumMod val="75000"/>
                    </a:schemeClr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5" name="TextBox 34"/>
                <p:cNvSpPr txBox="1"/>
                <p:nvPr/>
              </p:nvSpPr>
              <p:spPr>
                <a:xfrm>
                  <a:off x="4093817" y="4147081"/>
                  <a:ext cx="169539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dirty="0"/>
                    <a:t>Wild type</a:t>
                  </a:r>
                </a:p>
              </p:txBody>
            </p:sp>
          </p:grpSp>
          <p:grpSp>
            <p:nvGrpSpPr>
              <p:cNvPr id="31" name="Group 30"/>
              <p:cNvGrpSpPr/>
              <p:nvPr/>
            </p:nvGrpSpPr>
            <p:grpSpPr>
              <a:xfrm>
                <a:off x="5829197" y="3986500"/>
                <a:ext cx="1836000" cy="1807789"/>
                <a:chOff x="6076967" y="4119829"/>
                <a:chExt cx="1836000" cy="1807789"/>
              </a:xfrm>
            </p:grpSpPr>
            <p:pic>
              <p:nvPicPr>
                <p:cNvPr id="36" name="Picture 7" descr="C:\Users\mh40706\Desktop\Images T2\Rep 5\B12AZ\Maule\Untitled-39.tif"/>
                <p:cNvPicPr preferRelativeResize="0">
                  <a:picLocks noChangeArrowheads="1"/>
                </p:cNvPicPr>
                <p:nvPr/>
              </p:nvPicPr>
              <p:blipFill>
                <a:blip r:embed="rId11" cstate="print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11000" contrast="8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076967" y="4473218"/>
                  <a:ext cx="1836000" cy="1454400"/>
                </a:xfrm>
                <a:prstGeom prst="rect">
                  <a:avLst/>
                </a:prstGeom>
                <a:noFill/>
                <a:ln w="19050">
                  <a:solidFill>
                    <a:schemeClr val="tx2">
                      <a:lumMod val="75000"/>
                    </a:schemeClr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7" name="TextBox 36"/>
                <p:cNvSpPr txBox="1"/>
                <p:nvPr/>
              </p:nvSpPr>
              <p:spPr>
                <a:xfrm>
                  <a:off x="6220899" y="4119829"/>
                  <a:ext cx="153088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dirty="0" err="1"/>
                    <a:t>Azygote</a:t>
                  </a:r>
                  <a:endParaRPr lang="en-GB" dirty="0"/>
                </a:p>
              </p:txBody>
            </p:sp>
          </p:grpSp>
        </p:grpSp>
        <p:sp>
          <p:nvSpPr>
            <p:cNvPr id="20" name="Rectangle 19"/>
            <p:cNvSpPr/>
            <p:nvPr/>
          </p:nvSpPr>
          <p:spPr>
            <a:xfrm>
              <a:off x="8385992" y="4391646"/>
              <a:ext cx="35298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 err="1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f</a:t>
              </a:r>
              <a:endParaRPr lang="en-GB" dirty="0"/>
            </a:p>
          </p:txBody>
        </p:sp>
        <p:cxnSp>
          <p:nvCxnSpPr>
            <p:cNvPr id="43" name="Straight Arrow Connector 42"/>
            <p:cNvCxnSpPr/>
            <p:nvPr/>
          </p:nvCxnSpPr>
          <p:spPr>
            <a:xfrm flipH="1">
              <a:off x="8488218" y="4709873"/>
              <a:ext cx="74265" cy="23156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ctangle 49"/>
            <p:cNvSpPr/>
            <p:nvPr/>
          </p:nvSpPr>
          <p:spPr>
            <a:xfrm>
              <a:off x="7741040" y="5420412"/>
              <a:ext cx="37760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vs</a:t>
              </a:r>
              <a:endParaRPr lang="en-GB" dirty="0"/>
            </a:p>
          </p:txBody>
        </p:sp>
        <p:cxnSp>
          <p:nvCxnSpPr>
            <p:cNvPr id="51" name="Straight Arrow Connector 50"/>
            <p:cNvCxnSpPr/>
            <p:nvPr/>
          </p:nvCxnSpPr>
          <p:spPr>
            <a:xfrm flipH="1" flipV="1">
              <a:off x="7490692" y="5365544"/>
              <a:ext cx="344823" cy="16703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 flipV="1">
              <a:off x="7886576" y="5157834"/>
              <a:ext cx="34866" cy="34636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54834CA1-5842-4267-93E0-9F2A5D15E304}"/>
              </a:ext>
            </a:extLst>
          </p:cNvPr>
          <p:cNvSpPr txBox="1"/>
          <p:nvPr/>
        </p:nvSpPr>
        <p:spPr>
          <a:xfrm>
            <a:off x="640501" y="5466981"/>
            <a:ext cx="1092566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i="0" dirty="0">
                <a:solidFill>
                  <a:srgbClr val="2E2E2E"/>
                </a:solidFill>
                <a:effectLst/>
                <a:latin typeface="NexusSans"/>
              </a:rPr>
              <a:t>Fig. S6</a:t>
            </a:r>
            <a:r>
              <a:rPr lang="en-GB" b="0" i="0" dirty="0">
                <a:solidFill>
                  <a:srgbClr val="2E2E2E"/>
                </a:solidFill>
                <a:effectLst/>
                <a:latin typeface="NexusSans"/>
              </a:rPr>
              <a:t>: Histochemical staining of lignin in barley internode with Maule reagent revealed altered lignin composition in </a:t>
            </a:r>
            <a:r>
              <a:rPr lang="en-GB" b="0" i="1" dirty="0">
                <a:solidFill>
                  <a:srgbClr val="2E2E2E"/>
                </a:solidFill>
                <a:effectLst/>
                <a:latin typeface="NexusSans"/>
              </a:rPr>
              <a:t>HvF5H1</a:t>
            </a:r>
            <a:r>
              <a:rPr lang="en-GB" b="0" i="0" dirty="0">
                <a:solidFill>
                  <a:srgbClr val="2E2E2E"/>
                </a:solidFill>
                <a:effectLst/>
                <a:latin typeface="NexusSans"/>
              </a:rPr>
              <a:t> RNAi plants. The red colour is an indicator of </a:t>
            </a:r>
            <a:r>
              <a:rPr lang="en-GB" dirty="0" err="1">
                <a:solidFill>
                  <a:srgbClr val="2E2E2E"/>
                </a:solidFill>
                <a:latin typeface="NexusSans"/>
              </a:rPr>
              <a:t>s</a:t>
            </a:r>
            <a:r>
              <a:rPr lang="en-GB" b="0" i="0" dirty="0" err="1">
                <a:solidFill>
                  <a:srgbClr val="2E2E2E"/>
                </a:solidFill>
                <a:effectLst/>
                <a:latin typeface="NexusSans"/>
              </a:rPr>
              <a:t>yringyl</a:t>
            </a:r>
            <a:r>
              <a:rPr lang="en-GB" b="0" i="0" dirty="0">
                <a:solidFill>
                  <a:srgbClr val="2E2E2E"/>
                </a:solidFill>
                <a:effectLst/>
                <a:latin typeface="NexusSans"/>
              </a:rPr>
              <a:t> lignin which is mainly concentrated in cortical fibre and vascular bundles. </a:t>
            </a:r>
            <a:r>
              <a:rPr lang="en-GB" b="1" i="0" dirty="0" err="1">
                <a:solidFill>
                  <a:srgbClr val="2E2E2E"/>
                </a:solidFill>
                <a:effectLst/>
                <a:latin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rtical fibre and 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s: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ascular bundle; B,T and W are independent </a:t>
            </a:r>
            <a:r>
              <a:rPr lang="en-GB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vF5H1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NAi lines. Empty vector, Wild type and Azygote were used as control lines. Scale bars are 100 </a:t>
            </a:r>
            <a:r>
              <a:rPr lang="en-GB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μm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GB" dirty="0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B97900BF-3FA1-3FD0-A1AB-326714E4D7AB}"/>
              </a:ext>
            </a:extLst>
          </p:cNvPr>
          <p:cNvCxnSpPr>
            <a:cxnSpLocks/>
          </p:cNvCxnSpPr>
          <p:nvPr/>
        </p:nvCxnSpPr>
        <p:spPr>
          <a:xfrm>
            <a:off x="5424617" y="2805171"/>
            <a:ext cx="270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DD935B3D-2CE6-3A40-0BA3-65EA3F600B62}"/>
              </a:ext>
            </a:extLst>
          </p:cNvPr>
          <p:cNvCxnSpPr>
            <a:cxnSpLocks/>
          </p:cNvCxnSpPr>
          <p:nvPr/>
        </p:nvCxnSpPr>
        <p:spPr>
          <a:xfrm>
            <a:off x="8348360" y="2805171"/>
            <a:ext cx="270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8492895C-6E2B-3BD7-3233-0A23F13F2D4D}"/>
              </a:ext>
            </a:extLst>
          </p:cNvPr>
          <p:cNvCxnSpPr>
            <a:cxnSpLocks/>
          </p:cNvCxnSpPr>
          <p:nvPr/>
        </p:nvCxnSpPr>
        <p:spPr>
          <a:xfrm>
            <a:off x="4682917" y="4862571"/>
            <a:ext cx="270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977B001A-670B-2A3C-752C-D902094BE3D7}"/>
              </a:ext>
            </a:extLst>
          </p:cNvPr>
          <p:cNvCxnSpPr>
            <a:cxnSpLocks/>
          </p:cNvCxnSpPr>
          <p:nvPr/>
        </p:nvCxnSpPr>
        <p:spPr>
          <a:xfrm>
            <a:off x="4395917" y="2805171"/>
            <a:ext cx="270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E9FB2220-3C7B-37C0-E42C-68CCBB4CBE4C}"/>
              </a:ext>
            </a:extLst>
          </p:cNvPr>
          <p:cNvCxnSpPr>
            <a:cxnSpLocks/>
          </p:cNvCxnSpPr>
          <p:nvPr/>
        </p:nvCxnSpPr>
        <p:spPr>
          <a:xfrm>
            <a:off x="5393059" y="4867392"/>
            <a:ext cx="270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FA94C2CB-4668-58D4-BF25-76DEC7C35BEF}"/>
              </a:ext>
            </a:extLst>
          </p:cNvPr>
          <p:cNvCxnSpPr>
            <a:cxnSpLocks/>
          </p:cNvCxnSpPr>
          <p:nvPr/>
        </p:nvCxnSpPr>
        <p:spPr>
          <a:xfrm>
            <a:off x="7282232" y="4895967"/>
            <a:ext cx="270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222299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AA82BE5-DF74-0DE9-0FD4-B587A483D254}"/>
              </a:ext>
            </a:extLst>
          </p:cNvPr>
          <p:cNvSpPr txBox="1"/>
          <p:nvPr/>
        </p:nvSpPr>
        <p:spPr>
          <a:xfrm>
            <a:off x="750769" y="5350003"/>
            <a:ext cx="1113643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.S7</a:t>
            </a:r>
            <a:r>
              <a:rPr lang="en-GB" dirty="0"/>
              <a:t>: Alteration of lignin composition in HvF5H1 RNAi plants relative to the control lines. The straw characterisation was conducted using the </a:t>
            </a:r>
            <a:r>
              <a:rPr lang="en-GB" dirty="0" err="1"/>
              <a:t>thioacidolysis</a:t>
            </a:r>
            <a:r>
              <a:rPr lang="en-GB" dirty="0"/>
              <a:t> method. H, G and S are monolignols representing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-hydroxyphenyl, </a:t>
            </a:r>
            <a:r>
              <a:rPr lang="en-GB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aiacyl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syringyl units, respectively. </a:t>
            </a:r>
            <a:r>
              <a:rPr lang="en-GB" dirty="0"/>
              <a:t>The error bars represent standard errors between biological triplicates </a:t>
            </a:r>
            <a:r>
              <a:rPr lang="en-GB" sz="1800" dirty="0">
                <a:effectLst/>
                <a:ea typeface="Calibri" panose="020F0502020204030204" pitchFamily="34" charset="0"/>
              </a:rPr>
              <a:t>(i.e. independent plants).</a:t>
            </a:r>
            <a:endParaRPr lang="en-GB" dirty="0"/>
          </a:p>
        </p:txBody>
      </p:sp>
      <p:grpSp>
        <p:nvGrpSpPr>
          <p:cNvPr id="11" name="Group 10"/>
          <p:cNvGrpSpPr/>
          <p:nvPr/>
        </p:nvGrpSpPr>
        <p:grpSpPr>
          <a:xfrm>
            <a:off x="2368314" y="1071031"/>
            <a:ext cx="7324327" cy="3407663"/>
            <a:chOff x="2311164" y="1071031"/>
            <a:chExt cx="7324327" cy="3324603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07287" y="1071031"/>
              <a:ext cx="6932136" cy="2986049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FC95988-035B-4665-9E65-C3413A3A3B84}"/>
                </a:ext>
              </a:extLst>
            </p:cNvPr>
            <p:cNvSpPr txBox="1"/>
            <p:nvPr/>
          </p:nvSpPr>
          <p:spPr>
            <a:xfrm>
              <a:off x="3367776" y="4057080"/>
              <a:ext cx="25986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/>
                <a:t>Independent F5H RNAi line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5D3868B-0439-44CA-BCB9-9CAA9AEADDA1}"/>
                </a:ext>
              </a:extLst>
            </p:cNvPr>
            <p:cNvSpPr txBox="1"/>
            <p:nvPr/>
          </p:nvSpPr>
          <p:spPr>
            <a:xfrm>
              <a:off x="7145157" y="4057080"/>
              <a:ext cx="249033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/>
                <a:t>Control lines (</a:t>
              </a:r>
              <a:r>
                <a:rPr lang="en-GB" sz="1600" b="1" dirty="0" err="1"/>
                <a:t>Azygote</a:t>
              </a:r>
              <a:r>
                <a:rPr lang="en-GB" sz="1600" b="1" dirty="0"/>
                <a:t>) 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1263528" y="2177382"/>
              <a:ext cx="249538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/>
                <a:t>Relative quantity (%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4630355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925</TotalTime>
  <Words>579</Words>
  <Application>Microsoft Office PowerPoint</Application>
  <PresentationFormat>Widescreen</PresentationFormat>
  <Paragraphs>54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NexusSans</vt:lpstr>
      <vt:lpstr>Times New Roman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Dunde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za Shafiei</dc:creator>
  <cp:lastModifiedBy>Reza Shafiei (Staff)</cp:lastModifiedBy>
  <cp:revision>96</cp:revision>
  <dcterms:created xsi:type="dcterms:W3CDTF">2019-05-17T13:19:23Z</dcterms:created>
  <dcterms:modified xsi:type="dcterms:W3CDTF">2022-12-22T10:20:29Z</dcterms:modified>
</cp:coreProperties>
</file>